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50" d="100"/>
          <a:sy n="50" d="100"/>
        </p:scale>
        <p:origin x="28" y="10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Users\tshimoi\Dropbox\KMR%20&#21463;&#12369;&#30399;&#35430;&#39443;\NCCH1901%20dabtra%20&#35542;&#25991;\IHMOM_9_31032023-0837863\20230317N1901-1-OS(&#28204;&#23450;&#21487;&#33021;&#30149;&#22793;&#12354;&#12426;n=50)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D:\Users\tshimoi\Dropbox\KMR%20&#21463;&#12369;&#30399;&#35430;&#39443;\NCCH1901%20dabtra%20&#35542;&#25991;\IHMOM_9_31032023-0837863\20230317N1901-1-PFS(&#28204;&#23450;&#21487;&#33021;&#30149;&#22793;&#12354;&#12426;n=7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087733311028984"/>
          <c:y val="6.4166624889661114E-2"/>
          <c:w val="0.8159126365054602"/>
          <c:h val="0.76877102328213942"/>
        </c:manualLayout>
      </c:layout>
      <c:scatterChart>
        <c:scatterStyle val="lineMarker"/>
        <c:varyColors val="0"/>
        <c:ser>
          <c:idx val="0"/>
          <c:order val="0"/>
          <c:tx>
            <c:v>A群(n=83)</c:v>
          </c:tx>
          <c:spPr>
            <a:ln w="12700">
              <a:solidFill>
                <a:srgbClr val="000080"/>
              </a:solidFill>
              <a:prstDash val="solid"/>
            </a:ln>
          </c:spPr>
          <c:marker>
            <c:symbol val="none"/>
          </c:marker>
          <c:xVal>
            <c:numRef>
              <c:f>Sheet1!$A$1:$A$3500</c:f>
              <c:numCache>
                <c:formatCode>General</c:formatCode>
                <c:ptCount val="3500"/>
                <c:pt idx="0">
                  <c:v>0</c:v>
                </c:pt>
                <c:pt idx="1">
                  <c:v>0</c:v>
                </c:pt>
                <c:pt idx="2">
                  <c:v>3.3839835729000001</c:v>
                </c:pt>
                <c:pt idx="3">
                  <c:v>3.3839835729000001</c:v>
                </c:pt>
                <c:pt idx="4">
                  <c:v>3.9096509240000001</c:v>
                </c:pt>
                <c:pt idx="5">
                  <c:v>3.9096509240000001</c:v>
                </c:pt>
                <c:pt idx="6">
                  <c:v>4.0082135524</c:v>
                </c:pt>
                <c:pt idx="7">
                  <c:v>4.0082135524</c:v>
                </c:pt>
                <c:pt idx="8">
                  <c:v>4.0082135524</c:v>
                </c:pt>
                <c:pt idx="9">
                  <c:v>4.1067761806999998</c:v>
                </c:pt>
                <c:pt idx="10">
                  <c:v>4.1067761806999998</c:v>
                </c:pt>
                <c:pt idx="11">
                  <c:v>4.1067761806999998</c:v>
                </c:pt>
                <c:pt idx="12">
                  <c:v>4.1067761806999998</c:v>
                </c:pt>
                <c:pt idx="13">
                  <c:v>4.1067761806999998</c:v>
                </c:pt>
                <c:pt idx="14">
                  <c:v>4.1067761806999998</c:v>
                </c:pt>
                <c:pt idx="15">
                  <c:v>4.1067761806999998</c:v>
                </c:pt>
                <c:pt idx="16">
                  <c:v>4.1067761806999998</c:v>
                </c:pt>
                <c:pt idx="17">
                  <c:v>4.1067761806999998</c:v>
                </c:pt>
                <c:pt idx="18">
                  <c:v>4.1396303900999998</c:v>
                </c:pt>
                <c:pt idx="19">
                  <c:v>4.1396303900999998</c:v>
                </c:pt>
                <c:pt idx="20">
                  <c:v>4.1396303900999998</c:v>
                </c:pt>
                <c:pt idx="21">
                  <c:v>4.1724845995999997</c:v>
                </c:pt>
                <c:pt idx="22">
                  <c:v>4.1724845995999997</c:v>
                </c:pt>
                <c:pt idx="23">
                  <c:v>4.1724845995999997</c:v>
                </c:pt>
                <c:pt idx="24">
                  <c:v>4.2381930184999996</c:v>
                </c:pt>
                <c:pt idx="25">
                  <c:v>4.2381930184999996</c:v>
                </c:pt>
                <c:pt idx="26">
                  <c:v>4.2381930184999996</c:v>
                </c:pt>
                <c:pt idx="27">
                  <c:v>4.4024640657000003</c:v>
                </c:pt>
                <c:pt idx="28">
                  <c:v>4.4024640657000003</c:v>
                </c:pt>
                <c:pt idx="29">
                  <c:v>4.4024640657000003</c:v>
                </c:pt>
                <c:pt idx="30">
                  <c:v>4.4353182752000002</c:v>
                </c:pt>
                <c:pt idx="31">
                  <c:v>4.4353182752000002</c:v>
                </c:pt>
                <c:pt idx="32">
                  <c:v>4.4353182752000002</c:v>
                </c:pt>
                <c:pt idx="33">
                  <c:v>4.5010266940000001</c:v>
                </c:pt>
                <c:pt idx="34">
                  <c:v>4.5010266940000001</c:v>
                </c:pt>
                <c:pt idx="35">
                  <c:v>4.5010266940000001</c:v>
                </c:pt>
                <c:pt idx="36">
                  <c:v>4.5010266940000001</c:v>
                </c:pt>
                <c:pt idx="37">
                  <c:v>4.5010266940000001</c:v>
                </c:pt>
                <c:pt idx="38">
                  <c:v>4.5010266940000001</c:v>
                </c:pt>
                <c:pt idx="39">
                  <c:v>4.5995893224</c:v>
                </c:pt>
                <c:pt idx="40">
                  <c:v>4.5995893224</c:v>
                </c:pt>
                <c:pt idx="41">
                  <c:v>4.5995893224</c:v>
                </c:pt>
                <c:pt idx="42">
                  <c:v>4.6652977412999999</c:v>
                </c:pt>
                <c:pt idx="43">
                  <c:v>4.6652977412999999</c:v>
                </c:pt>
                <c:pt idx="44">
                  <c:v>5.158110883</c:v>
                </c:pt>
                <c:pt idx="45">
                  <c:v>5.158110883</c:v>
                </c:pt>
                <c:pt idx="46">
                  <c:v>5.158110883</c:v>
                </c:pt>
                <c:pt idx="47">
                  <c:v>5.1909650923999999</c:v>
                </c:pt>
                <c:pt idx="48">
                  <c:v>5.1909650923999999</c:v>
                </c:pt>
                <c:pt idx="49">
                  <c:v>5.2566735112999998</c:v>
                </c:pt>
                <c:pt idx="50">
                  <c:v>5.2566735112999998</c:v>
                </c:pt>
                <c:pt idx="51">
                  <c:v>5.2566735112999998</c:v>
                </c:pt>
                <c:pt idx="52">
                  <c:v>5.6837782341</c:v>
                </c:pt>
                <c:pt idx="53">
                  <c:v>5.6837782341</c:v>
                </c:pt>
                <c:pt idx="54">
                  <c:v>5.8809034907999997</c:v>
                </c:pt>
                <c:pt idx="55">
                  <c:v>5.8809034907999997</c:v>
                </c:pt>
                <c:pt idx="56">
                  <c:v>5.8809034907999997</c:v>
                </c:pt>
                <c:pt idx="57">
                  <c:v>6.5379876796999996</c:v>
                </c:pt>
                <c:pt idx="58">
                  <c:v>6.5379876796999996</c:v>
                </c:pt>
                <c:pt idx="59">
                  <c:v>6.5708418891000004</c:v>
                </c:pt>
                <c:pt idx="60">
                  <c:v>6.5708418891000004</c:v>
                </c:pt>
                <c:pt idx="61">
                  <c:v>6.7022587269000002</c:v>
                </c:pt>
                <c:pt idx="62">
                  <c:v>6.7022587269000002</c:v>
                </c:pt>
                <c:pt idx="63">
                  <c:v>6.8336755647</c:v>
                </c:pt>
                <c:pt idx="64">
                  <c:v>6.8336755647</c:v>
                </c:pt>
                <c:pt idx="65">
                  <c:v>6.8993839835999999</c:v>
                </c:pt>
                <c:pt idx="66">
                  <c:v>6.8993839835999999</c:v>
                </c:pt>
                <c:pt idx="67">
                  <c:v>6.8993839835999999</c:v>
                </c:pt>
                <c:pt idx="68">
                  <c:v>7.0965092401999996</c:v>
                </c:pt>
                <c:pt idx="69">
                  <c:v>7.0965092401999996</c:v>
                </c:pt>
                <c:pt idx="70">
                  <c:v>7.1622176591000004</c:v>
                </c:pt>
                <c:pt idx="71">
                  <c:v>7.1622176591000004</c:v>
                </c:pt>
                <c:pt idx="72">
                  <c:v>7.1622176591000004</c:v>
                </c:pt>
                <c:pt idx="73">
                  <c:v>7.3264887064000002</c:v>
                </c:pt>
                <c:pt idx="74">
                  <c:v>7.3264887064000002</c:v>
                </c:pt>
                <c:pt idx="75">
                  <c:v>7.4579055441</c:v>
                </c:pt>
                <c:pt idx="76">
                  <c:v>7.4579055441</c:v>
                </c:pt>
                <c:pt idx="77">
                  <c:v>7.7207392197000004</c:v>
                </c:pt>
                <c:pt idx="78">
                  <c:v>7.7207392197000004</c:v>
                </c:pt>
                <c:pt idx="79">
                  <c:v>7.7207392197000004</c:v>
                </c:pt>
                <c:pt idx="80">
                  <c:v>7.8521560575000002</c:v>
                </c:pt>
                <c:pt idx="81">
                  <c:v>7.8521560575000002</c:v>
                </c:pt>
                <c:pt idx="82">
                  <c:v>8.0492813141999999</c:v>
                </c:pt>
                <c:pt idx="83">
                  <c:v>8.0492813141999999</c:v>
                </c:pt>
                <c:pt idx="84">
                  <c:v>8.0492813141999999</c:v>
                </c:pt>
                <c:pt idx="85">
                  <c:v>9.0020533881000002</c:v>
                </c:pt>
                <c:pt idx="86">
                  <c:v>9.0020533881000002</c:v>
                </c:pt>
                <c:pt idx="87">
                  <c:v>9.0677618070000001</c:v>
                </c:pt>
                <c:pt idx="88">
                  <c:v>9.0677618070000001</c:v>
                </c:pt>
                <c:pt idx="89">
                  <c:v>9.3963039013999996</c:v>
                </c:pt>
                <c:pt idx="90">
                  <c:v>9.3963039013999996</c:v>
                </c:pt>
                <c:pt idx="91">
                  <c:v>9.6591375769999992</c:v>
                </c:pt>
                <c:pt idx="92">
                  <c:v>9.6591375769999992</c:v>
                </c:pt>
                <c:pt idx="93">
                  <c:v>10.119096509</c:v>
                </c:pt>
                <c:pt idx="94">
                  <c:v>10.119096509</c:v>
                </c:pt>
                <c:pt idx="95">
                  <c:v>10.119096509</c:v>
                </c:pt>
                <c:pt idx="96">
                  <c:v>10.151950719</c:v>
                </c:pt>
                <c:pt idx="97">
                  <c:v>10.151950719</c:v>
                </c:pt>
                <c:pt idx="98">
                  <c:v>10.151950719</c:v>
                </c:pt>
                <c:pt idx="99">
                  <c:v>10.973305955000001</c:v>
                </c:pt>
                <c:pt idx="100">
                  <c:v>10.973305955000001</c:v>
                </c:pt>
                <c:pt idx="101">
                  <c:v>11.039014374000001</c:v>
                </c:pt>
                <c:pt idx="102">
                  <c:v>11.039014374000001</c:v>
                </c:pt>
                <c:pt idx="103">
                  <c:v>11.104722793000001</c:v>
                </c:pt>
                <c:pt idx="104">
                  <c:v>11.104722793000001</c:v>
                </c:pt>
                <c:pt idx="105">
                  <c:v>11.663244353</c:v>
                </c:pt>
                <c:pt idx="106">
                  <c:v>11.663244353</c:v>
                </c:pt>
                <c:pt idx="107">
                  <c:v>11.663244353</c:v>
                </c:pt>
                <c:pt idx="108">
                  <c:v>12.188911704000001</c:v>
                </c:pt>
                <c:pt idx="109">
                  <c:v>12.188911704000001</c:v>
                </c:pt>
                <c:pt idx="110">
                  <c:v>14.094455851999999</c:v>
                </c:pt>
                <c:pt idx="111">
                  <c:v>14.094455851999999</c:v>
                </c:pt>
                <c:pt idx="112">
                  <c:v>15.967145791</c:v>
                </c:pt>
                <c:pt idx="113">
                  <c:v>15.967145791</c:v>
                </c:pt>
                <c:pt idx="114">
                  <c:v>15.967145791</c:v>
                </c:pt>
                <c:pt idx="115">
                  <c:v>16.229979466</c:v>
                </c:pt>
                <c:pt idx="116">
                  <c:v>16.229979466</c:v>
                </c:pt>
                <c:pt idx="117">
                  <c:v>16.229979466</c:v>
                </c:pt>
                <c:pt idx="118">
                  <c:v>17.938398357000001</c:v>
                </c:pt>
                <c:pt idx="119">
                  <c:v>17.938398357000001</c:v>
                </c:pt>
                <c:pt idx="120">
                  <c:v>22.833675565</c:v>
                </c:pt>
                <c:pt idx="121">
                  <c:v>22.833675565</c:v>
                </c:pt>
                <c:pt idx="122">
                  <c:v>24.147843943000002</c:v>
                </c:pt>
                <c:pt idx="123">
                  <c:v>24.147843943000002</c:v>
                </c:pt>
                <c:pt idx="124">
                  <c:v>24.476386037000001</c:v>
                </c:pt>
                <c:pt idx="125">
                  <c:v>24.476386037000001</c:v>
                </c:pt>
                <c:pt idx="126">
                  <c:v>24.476386037000001</c:v>
                </c:pt>
              </c:numCache>
            </c:numRef>
          </c:xVal>
          <c:yVal>
            <c:numRef>
              <c:f>Sheet1!$B$1:$B$3500</c:f>
              <c:numCache>
                <c:formatCode>General</c:formatCode>
                <c:ptCount val="350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98</c:v>
                </c:pt>
                <c:pt idx="4">
                  <c:v>0.98</c:v>
                </c:pt>
                <c:pt idx="5">
                  <c:v>0.96</c:v>
                </c:pt>
                <c:pt idx="6">
                  <c:v>0.96</c:v>
                </c:pt>
                <c:pt idx="7">
                  <c:v>0.98</c:v>
                </c:pt>
                <c:pt idx="8">
                  <c:v>0.96</c:v>
                </c:pt>
                <c:pt idx="9">
                  <c:v>0.96</c:v>
                </c:pt>
                <c:pt idx="10">
                  <c:v>0.98</c:v>
                </c:pt>
                <c:pt idx="11">
                  <c:v>0.96</c:v>
                </c:pt>
                <c:pt idx="12">
                  <c:v>0.96</c:v>
                </c:pt>
                <c:pt idx="13">
                  <c:v>0.98</c:v>
                </c:pt>
                <c:pt idx="14">
                  <c:v>0.96</c:v>
                </c:pt>
                <c:pt idx="15">
                  <c:v>0.96</c:v>
                </c:pt>
                <c:pt idx="16">
                  <c:v>0.98</c:v>
                </c:pt>
                <c:pt idx="17">
                  <c:v>0.96</c:v>
                </c:pt>
                <c:pt idx="18">
                  <c:v>0.96</c:v>
                </c:pt>
                <c:pt idx="19">
                  <c:v>0.98</c:v>
                </c:pt>
                <c:pt idx="20">
                  <c:v>0.96</c:v>
                </c:pt>
                <c:pt idx="21">
                  <c:v>0.96</c:v>
                </c:pt>
                <c:pt idx="22">
                  <c:v>0.98</c:v>
                </c:pt>
                <c:pt idx="23">
                  <c:v>0.96</c:v>
                </c:pt>
                <c:pt idx="24">
                  <c:v>0.96</c:v>
                </c:pt>
                <c:pt idx="25">
                  <c:v>0.98</c:v>
                </c:pt>
                <c:pt idx="26">
                  <c:v>0.96</c:v>
                </c:pt>
                <c:pt idx="27">
                  <c:v>0.96</c:v>
                </c:pt>
                <c:pt idx="28">
                  <c:v>0.98</c:v>
                </c:pt>
                <c:pt idx="29">
                  <c:v>0.96</c:v>
                </c:pt>
                <c:pt idx="30">
                  <c:v>0.96</c:v>
                </c:pt>
                <c:pt idx="31">
                  <c:v>0.98</c:v>
                </c:pt>
                <c:pt idx="32">
                  <c:v>0.96</c:v>
                </c:pt>
                <c:pt idx="33">
                  <c:v>0.96</c:v>
                </c:pt>
                <c:pt idx="34">
                  <c:v>0.98</c:v>
                </c:pt>
                <c:pt idx="35">
                  <c:v>0.96</c:v>
                </c:pt>
                <c:pt idx="36">
                  <c:v>0.96</c:v>
                </c:pt>
                <c:pt idx="37">
                  <c:v>0.98</c:v>
                </c:pt>
                <c:pt idx="38">
                  <c:v>0.96</c:v>
                </c:pt>
                <c:pt idx="39">
                  <c:v>0.96</c:v>
                </c:pt>
                <c:pt idx="40">
                  <c:v>0.98</c:v>
                </c:pt>
                <c:pt idx="41">
                  <c:v>0.96</c:v>
                </c:pt>
                <c:pt idx="42">
                  <c:v>0.96</c:v>
                </c:pt>
                <c:pt idx="43">
                  <c:v>0.93333333330000001</c:v>
                </c:pt>
                <c:pt idx="44">
                  <c:v>0.93333333330000001</c:v>
                </c:pt>
                <c:pt idx="45">
                  <c:v>0.95333333330000003</c:v>
                </c:pt>
                <c:pt idx="46">
                  <c:v>0.93333333330000001</c:v>
                </c:pt>
                <c:pt idx="47">
                  <c:v>0.93333333330000001</c:v>
                </c:pt>
                <c:pt idx="48">
                  <c:v>0.90588235289999997</c:v>
                </c:pt>
                <c:pt idx="49">
                  <c:v>0.90588235289999997</c:v>
                </c:pt>
                <c:pt idx="50">
                  <c:v>0.92588235289999998</c:v>
                </c:pt>
                <c:pt idx="51">
                  <c:v>0.90588235289999997</c:v>
                </c:pt>
                <c:pt idx="52">
                  <c:v>0.90588235289999997</c:v>
                </c:pt>
                <c:pt idx="53">
                  <c:v>0.8775735294</c:v>
                </c:pt>
                <c:pt idx="54">
                  <c:v>0.8775735294</c:v>
                </c:pt>
                <c:pt idx="55">
                  <c:v>0.89757352940000001</c:v>
                </c:pt>
                <c:pt idx="56">
                  <c:v>0.8775735294</c:v>
                </c:pt>
                <c:pt idx="57">
                  <c:v>0.8775735294</c:v>
                </c:pt>
                <c:pt idx="58">
                  <c:v>0.84832107840000004</c:v>
                </c:pt>
                <c:pt idx="59">
                  <c:v>0.84832107840000004</c:v>
                </c:pt>
                <c:pt idx="60">
                  <c:v>0.81906862749999998</c:v>
                </c:pt>
                <c:pt idx="61">
                  <c:v>0.81906862749999998</c:v>
                </c:pt>
                <c:pt idx="62">
                  <c:v>0.78981617650000002</c:v>
                </c:pt>
                <c:pt idx="63">
                  <c:v>0.78981617650000002</c:v>
                </c:pt>
                <c:pt idx="64">
                  <c:v>0.76056372549999995</c:v>
                </c:pt>
                <c:pt idx="65">
                  <c:v>0.76056372549999995</c:v>
                </c:pt>
                <c:pt idx="66">
                  <c:v>0.78056372549999997</c:v>
                </c:pt>
                <c:pt idx="67">
                  <c:v>0.76056372549999995</c:v>
                </c:pt>
                <c:pt idx="68">
                  <c:v>0.76056372549999995</c:v>
                </c:pt>
                <c:pt idx="69">
                  <c:v>0.73014117649999999</c:v>
                </c:pt>
                <c:pt idx="70">
                  <c:v>0.73014117649999999</c:v>
                </c:pt>
                <c:pt idx="71">
                  <c:v>0.75014117650000001</c:v>
                </c:pt>
                <c:pt idx="72">
                  <c:v>0.73014117649999999</c:v>
                </c:pt>
                <c:pt idx="73">
                  <c:v>0.73014117649999999</c:v>
                </c:pt>
                <c:pt idx="74">
                  <c:v>0.69839590789999995</c:v>
                </c:pt>
                <c:pt idx="75">
                  <c:v>0.69839590789999995</c:v>
                </c:pt>
                <c:pt idx="76">
                  <c:v>0.66665063940000002</c:v>
                </c:pt>
                <c:pt idx="77">
                  <c:v>0.66665063940000002</c:v>
                </c:pt>
                <c:pt idx="78">
                  <c:v>0.68665063940000004</c:v>
                </c:pt>
                <c:pt idx="79">
                  <c:v>0.66665063940000002</c:v>
                </c:pt>
                <c:pt idx="80">
                  <c:v>0.66665063940000002</c:v>
                </c:pt>
                <c:pt idx="81">
                  <c:v>0.63331810740000005</c:v>
                </c:pt>
                <c:pt idx="82">
                  <c:v>0.63331810740000005</c:v>
                </c:pt>
                <c:pt idx="83">
                  <c:v>0.65331810739999996</c:v>
                </c:pt>
                <c:pt idx="84">
                  <c:v>0.63331810740000005</c:v>
                </c:pt>
                <c:pt idx="85">
                  <c:v>0.63331810740000005</c:v>
                </c:pt>
                <c:pt idx="86">
                  <c:v>0.59813376809999996</c:v>
                </c:pt>
                <c:pt idx="87">
                  <c:v>0.59813376809999996</c:v>
                </c:pt>
                <c:pt idx="88">
                  <c:v>0.56294942879999998</c:v>
                </c:pt>
                <c:pt idx="89">
                  <c:v>0.56294942879999998</c:v>
                </c:pt>
                <c:pt idx="90">
                  <c:v>0.52776508950000001</c:v>
                </c:pt>
                <c:pt idx="91">
                  <c:v>0.52776508950000001</c:v>
                </c:pt>
                <c:pt idx="92">
                  <c:v>0.49258075019999997</c:v>
                </c:pt>
                <c:pt idx="93">
                  <c:v>0.49258075019999997</c:v>
                </c:pt>
                <c:pt idx="94">
                  <c:v>0.51258075020000005</c:v>
                </c:pt>
                <c:pt idx="95">
                  <c:v>0.49258075019999997</c:v>
                </c:pt>
                <c:pt idx="96">
                  <c:v>0.49258075019999997</c:v>
                </c:pt>
                <c:pt idx="97">
                  <c:v>0.51258075020000005</c:v>
                </c:pt>
                <c:pt idx="98">
                  <c:v>0.49258075019999997</c:v>
                </c:pt>
                <c:pt idx="99">
                  <c:v>0.49258075019999997</c:v>
                </c:pt>
                <c:pt idx="100">
                  <c:v>0.4515323544</c:v>
                </c:pt>
                <c:pt idx="101">
                  <c:v>0.4515323544</c:v>
                </c:pt>
                <c:pt idx="102">
                  <c:v>0.41048395850000002</c:v>
                </c:pt>
                <c:pt idx="103">
                  <c:v>0.41048395850000002</c:v>
                </c:pt>
                <c:pt idx="104">
                  <c:v>0.3694355627</c:v>
                </c:pt>
                <c:pt idx="105">
                  <c:v>0.3694355627</c:v>
                </c:pt>
                <c:pt idx="106">
                  <c:v>0.38943556270000002</c:v>
                </c:pt>
                <c:pt idx="107">
                  <c:v>0.3694355627</c:v>
                </c:pt>
                <c:pt idx="108">
                  <c:v>0.3694355627</c:v>
                </c:pt>
                <c:pt idx="109">
                  <c:v>0.32325611729999998</c:v>
                </c:pt>
                <c:pt idx="110">
                  <c:v>0.32325611729999998</c:v>
                </c:pt>
                <c:pt idx="111">
                  <c:v>0.27707667200000002</c:v>
                </c:pt>
                <c:pt idx="112">
                  <c:v>0.27707667200000002</c:v>
                </c:pt>
                <c:pt idx="113">
                  <c:v>0.29707667199999999</c:v>
                </c:pt>
                <c:pt idx="114">
                  <c:v>0.27707667200000002</c:v>
                </c:pt>
                <c:pt idx="115">
                  <c:v>0.27707667200000002</c:v>
                </c:pt>
                <c:pt idx="116">
                  <c:v>0.29707667199999999</c:v>
                </c:pt>
                <c:pt idx="117">
                  <c:v>0.27707667200000002</c:v>
                </c:pt>
                <c:pt idx="118">
                  <c:v>0.27707667200000002</c:v>
                </c:pt>
                <c:pt idx="119">
                  <c:v>0.207807504</c:v>
                </c:pt>
                <c:pt idx="120">
                  <c:v>0.207807504</c:v>
                </c:pt>
                <c:pt idx="121">
                  <c:v>0.13853833600000001</c:v>
                </c:pt>
                <c:pt idx="122">
                  <c:v>0.13853833600000001</c:v>
                </c:pt>
                <c:pt idx="123">
                  <c:v>6.9269168000000006E-2</c:v>
                </c:pt>
                <c:pt idx="124">
                  <c:v>6.9269168000000006E-2</c:v>
                </c:pt>
                <c:pt idx="125">
                  <c:v>8.9269167999999996E-2</c:v>
                </c:pt>
                <c:pt idx="126">
                  <c:v>6.926916800000000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384-4051-B59C-1FB0491593C9}"/>
            </c:ext>
          </c:extLst>
        </c:ser>
        <c:ser>
          <c:idx val="1"/>
          <c:order val="1"/>
          <c:tx>
            <c:v>B群(n=82)</c:v>
          </c:tx>
          <c:spPr>
            <a:ln w="12700">
              <a:solidFill>
                <a:srgbClr val="FF00FF"/>
              </a:solidFill>
              <a:prstDash val="solid"/>
            </a:ln>
          </c:spPr>
          <c:marker>
            <c:symbol val="none"/>
          </c:marker>
          <c:xVal>
            <c:numRef>
              <c:f>Sheet1!$C$1:$C$3500</c:f>
              <c:numCache>
                <c:formatCode>General</c:formatCode>
                <c:ptCount val="3500"/>
              </c:numCache>
            </c:numRef>
          </c:xVal>
          <c:yVal>
            <c:numRef>
              <c:f>Sheet1!$D$1:$D$3500</c:f>
              <c:numCache>
                <c:formatCode>General</c:formatCode>
                <c:ptCount val="3500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384-4051-B59C-1FB0491593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0893512"/>
        <c:axId val="1"/>
      </c:scatterChart>
      <c:valAx>
        <c:axId val="320893512"/>
        <c:scaling>
          <c:orientation val="minMax"/>
          <c:max val="25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150" b="0" i="0" u="none" strike="noStrike" baseline="0">
                <a:solidFill>
                  <a:srgbClr val="000000"/>
                </a:solidFill>
                <a:latin typeface="ＭＳ Ｐゴシック"/>
                <a:ea typeface="ＭＳ Ｐゴシック"/>
                <a:cs typeface="ＭＳ Ｐゴシック"/>
              </a:defRPr>
            </a:pPr>
            <a:endParaRPr lang="ja-JP"/>
          </a:p>
        </c:txPr>
        <c:crossAx val="1"/>
        <c:crosses val="autoZero"/>
        <c:crossBetween val="midCat"/>
        <c:majorUnit val="1"/>
      </c:valAx>
      <c:valAx>
        <c:axId val="1"/>
        <c:scaling>
          <c:orientation val="minMax"/>
          <c:max val="1.05"/>
          <c:min val="0"/>
        </c:scaling>
        <c:delete val="0"/>
        <c:axPos val="l"/>
        <c:numFmt formatCode="0.0_ " sourceLinked="0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150" b="0" i="0" u="none" strike="noStrike" baseline="0">
                <a:solidFill>
                  <a:srgbClr val="000000"/>
                </a:solidFill>
                <a:latin typeface="ＭＳ Ｐゴシック"/>
                <a:ea typeface="ＭＳ Ｐゴシック"/>
                <a:cs typeface="ＭＳ Ｐゴシック"/>
              </a:defRPr>
            </a:pPr>
            <a:endParaRPr lang="ja-JP"/>
          </a:p>
        </c:txPr>
        <c:crossAx val="320893512"/>
        <c:crosses val="autoZero"/>
        <c:crossBetween val="midCat"/>
        <c:majorUnit val="0.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6350">
      <a:noFill/>
    </a:ln>
  </c:spPr>
  <c:txPr>
    <a:bodyPr/>
    <a:lstStyle/>
    <a:p>
      <a:pPr>
        <a:defRPr sz="115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087733311028984"/>
          <c:y val="6.4166624889661114E-2"/>
          <c:w val="0.8159126365054602"/>
          <c:h val="0.76877102328213942"/>
        </c:manualLayout>
      </c:layout>
      <c:scatterChart>
        <c:scatterStyle val="lineMarker"/>
        <c:varyColors val="0"/>
        <c:ser>
          <c:idx val="0"/>
          <c:order val="0"/>
          <c:tx>
            <c:v>A群(n=83)</c:v>
          </c:tx>
          <c:spPr>
            <a:ln w="12700">
              <a:solidFill>
                <a:srgbClr val="000080"/>
              </a:solidFill>
              <a:prstDash val="solid"/>
            </a:ln>
          </c:spPr>
          <c:marker>
            <c:symbol val="none"/>
          </c:marker>
          <c:xVal>
            <c:numRef>
              <c:f>Sheet1!$A$1:$A$3500</c:f>
              <c:numCache>
                <c:formatCode>General</c:formatCode>
                <c:ptCount val="3500"/>
                <c:pt idx="0">
                  <c:v>0</c:v>
                </c:pt>
                <c:pt idx="1">
                  <c:v>0</c:v>
                </c:pt>
                <c:pt idx="2">
                  <c:v>3.2854209400000001E-2</c:v>
                </c:pt>
                <c:pt idx="3">
                  <c:v>3.2854209400000001E-2</c:v>
                </c:pt>
                <c:pt idx="4">
                  <c:v>3.2854209400000001E-2</c:v>
                </c:pt>
                <c:pt idx="5">
                  <c:v>3.2854209400000001E-2</c:v>
                </c:pt>
                <c:pt idx="6">
                  <c:v>3.2854209400000001E-2</c:v>
                </c:pt>
                <c:pt idx="7">
                  <c:v>3.2854209400000001E-2</c:v>
                </c:pt>
                <c:pt idx="8">
                  <c:v>3.2854209400000001E-2</c:v>
                </c:pt>
                <c:pt idx="9">
                  <c:v>3.2854209400000001E-2</c:v>
                </c:pt>
                <c:pt idx="10">
                  <c:v>3.2854209400000001E-2</c:v>
                </c:pt>
                <c:pt idx="11">
                  <c:v>3.2854209400000001E-2</c:v>
                </c:pt>
                <c:pt idx="12">
                  <c:v>3.2854209400000001E-2</c:v>
                </c:pt>
                <c:pt idx="13">
                  <c:v>3.2854209400000001E-2</c:v>
                </c:pt>
                <c:pt idx="14">
                  <c:v>0.7885010267</c:v>
                </c:pt>
                <c:pt idx="15">
                  <c:v>0.7885010267</c:v>
                </c:pt>
                <c:pt idx="16">
                  <c:v>4.4681724846000002</c:v>
                </c:pt>
                <c:pt idx="17">
                  <c:v>4.4681724846000002</c:v>
                </c:pt>
                <c:pt idx="18">
                  <c:v>8.6078028747000008</c:v>
                </c:pt>
                <c:pt idx="19">
                  <c:v>8.6078028747000008</c:v>
                </c:pt>
              </c:numCache>
            </c:numRef>
          </c:xVal>
          <c:yVal>
            <c:numRef>
              <c:f>Sheet1!$B$1:$B$3500</c:f>
              <c:numCache>
                <c:formatCode>General</c:formatCode>
                <c:ptCount val="350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.02</c:v>
                </c:pt>
                <c:pt idx="4">
                  <c:v>1</c:v>
                </c:pt>
                <c:pt idx="5">
                  <c:v>1</c:v>
                </c:pt>
                <c:pt idx="6">
                  <c:v>1.02</c:v>
                </c:pt>
                <c:pt idx="7">
                  <c:v>1</c:v>
                </c:pt>
                <c:pt idx="8">
                  <c:v>1</c:v>
                </c:pt>
                <c:pt idx="9">
                  <c:v>1.02</c:v>
                </c:pt>
                <c:pt idx="10">
                  <c:v>1</c:v>
                </c:pt>
                <c:pt idx="11">
                  <c:v>1</c:v>
                </c:pt>
                <c:pt idx="12">
                  <c:v>1.02</c:v>
                </c:pt>
                <c:pt idx="13">
                  <c:v>1</c:v>
                </c:pt>
                <c:pt idx="14">
                  <c:v>1</c:v>
                </c:pt>
                <c:pt idx="15">
                  <c:v>0.66666666669999997</c:v>
                </c:pt>
                <c:pt idx="16">
                  <c:v>0.66666666669999997</c:v>
                </c:pt>
                <c:pt idx="17">
                  <c:v>0.33333333329999998</c:v>
                </c:pt>
                <c:pt idx="18">
                  <c:v>0.33333333329999998</c:v>
                </c:pt>
                <c:pt idx="1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F02-4D80-8F75-B7396D9ABEB9}"/>
            </c:ext>
          </c:extLst>
        </c:ser>
        <c:ser>
          <c:idx val="1"/>
          <c:order val="1"/>
          <c:tx>
            <c:v>B群(n=82)</c:v>
          </c:tx>
          <c:spPr>
            <a:ln w="12700">
              <a:solidFill>
                <a:srgbClr val="FF00FF"/>
              </a:solidFill>
              <a:prstDash val="solid"/>
            </a:ln>
          </c:spPr>
          <c:marker>
            <c:symbol val="none"/>
          </c:marker>
          <c:xVal>
            <c:numRef>
              <c:f>Sheet1!$C$1:$C$3500</c:f>
              <c:numCache>
                <c:formatCode>General</c:formatCode>
                <c:ptCount val="3500"/>
              </c:numCache>
            </c:numRef>
          </c:xVal>
          <c:yVal>
            <c:numRef>
              <c:f>Sheet1!$D$1:$D$3500</c:f>
              <c:numCache>
                <c:formatCode>General</c:formatCode>
                <c:ptCount val="3500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F02-4D80-8F75-B7396D9ABE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0893512"/>
        <c:axId val="1"/>
      </c:scatterChart>
      <c:valAx>
        <c:axId val="320893512"/>
        <c:scaling>
          <c:orientation val="minMax"/>
          <c:max val="25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150" b="0" i="0" u="none" strike="noStrike" baseline="0">
                <a:solidFill>
                  <a:srgbClr val="000000"/>
                </a:solidFill>
                <a:latin typeface="ＭＳ Ｐゴシック"/>
                <a:ea typeface="ＭＳ Ｐゴシック"/>
                <a:cs typeface="ＭＳ Ｐゴシック"/>
              </a:defRPr>
            </a:pPr>
            <a:endParaRPr lang="ja-JP"/>
          </a:p>
        </c:txPr>
        <c:crossAx val="1"/>
        <c:crosses val="autoZero"/>
        <c:crossBetween val="midCat"/>
        <c:majorUnit val="1"/>
      </c:valAx>
      <c:valAx>
        <c:axId val="1"/>
        <c:scaling>
          <c:orientation val="minMax"/>
          <c:max val="1.05"/>
          <c:min val="0"/>
        </c:scaling>
        <c:delete val="0"/>
        <c:axPos val="l"/>
        <c:numFmt formatCode="0.0_ " sourceLinked="0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150" b="0" i="0" u="none" strike="noStrike" baseline="0">
                <a:solidFill>
                  <a:srgbClr val="000000"/>
                </a:solidFill>
                <a:latin typeface="ＭＳ Ｐゴシック"/>
                <a:ea typeface="ＭＳ Ｐゴシック"/>
                <a:cs typeface="ＭＳ Ｐゴシック"/>
              </a:defRPr>
            </a:pPr>
            <a:endParaRPr lang="ja-JP"/>
          </a:p>
        </c:txPr>
        <c:crossAx val="320893512"/>
        <c:crosses val="autoZero"/>
        <c:crossBetween val="midCat"/>
        <c:majorUnit val="0.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6350">
      <a:noFill/>
    </a:ln>
  </c:spPr>
  <c:txPr>
    <a:bodyPr/>
    <a:lstStyle/>
    <a:p>
      <a:pPr>
        <a:defRPr sz="115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8443</cdr:x>
      <cdr:y>0.90414</cdr:y>
    </cdr:from>
    <cdr:to>
      <cdr:x>0.58055</cdr:x>
      <cdr:y>0.94905</cdr:y>
    </cdr:to>
    <cdr:sp macro="" textlink="">
      <cdr:nvSpPr>
        <cdr:cNvPr id="2049" name="Text Box 1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4042512" y="3934219"/>
          <a:ext cx="2062296" cy="19543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18288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en-US" altLang="ja-JP" sz="1150" b="0" i="0" u="none" strike="noStrike" baseline="0" dirty="0">
              <a:solidFill>
                <a:srgbClr val="000000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rPr>
            <a:t>Time from Registration (Month)</a:t>
          </a:r>
          <a:endParaRPr lang="ja-JP" altLang="en-US" sz="1150" b="0" i="0" u="none" strike="noStrike" baseline="0" dirty="0">
            <a:solidFill>
              <a:srgbClr val="000000"/>
            </a:solidFill>
            <a:latin typeface="Arial" panose="020B0604020202020204" pitchFamily="34" charset="0"/>
            <a:ea typeface="ＭＳ Ｐゴシック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00433</cdr:x>
      <cdr:y>0.20742</cdr:y>
    </cdr:from>
    <cdr:to>
      <cdr:x>0.05011</cdr:x>
      <cdr:y>0.74237</cdr:y>
    </cdr:to>
    <cdr:sp macro="" textlink="">
      <cdr:nvSpPr>
        <cdr:cNvPr id="2050" name="Text Box 2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6819" y="664959"/>
          <a:ext cx="283278" cy="17149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vert="vert270" wrap="square" lIns="27432" tIns="0" rIns="0" bIns="0" anchor="b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en-US" altLang="ja-JP" sz="1150" b="0" i="0" u="none" strike="noStrike" baseline="0">
              <a:solidFill>
                <a:srgbClr val="000000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rPr>
            <a:t>Overall Survival Probability</a:t>
          </a:r>
          <a:endParaRPr lang="ja-JP" altLang="en-US" sz="1150" b="0" i="0" u="none" strike="noStrike" baseline="0">
            <a:solidFill>
              <a:srgbClr val="000000"/>
            </a:solidFill>
            <a:latin typeface="Arial" panose="020B0604020202020204" pitchFamily="34" charset="0"/>
            <a:ea typeface="ＭＳ Ｐゴシック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8443</cdr:x>
      <cdr:y>0.90414</cdr:y>
    </cdr:from>
    <cdr:to>
      <cdr:x>0.58055</cdr:x>
      <cdr:y>0.94905</cdr:y>
    </cdr:to>
    <cdr:sp macro="" textlink="">
      <cdr:nvSpPr>
        <cdr:cNvPr id="2049" name="Text Box 1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4042512" y="3934219"/>
          <a:ext cx="2062296" cy="19543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18288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en-US" altLang="ja-JP" sz="1150" b="0" i="0" u="none" strike="noStrike" baseline="0">
              <a:solidFill>
                <a:srgbClr val="000000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rPr>
            <a:t>Time from Registration (Month)</a:t>
          </a:r>
          <a:endParaRPr lang="ja-JP" altLang="en-US" sz="1150" b="0" i="0" u="none" strike="noStrike" baseline="0">
            <a:solidFill>
              <a:srgbClr val="000000"/>
            </a:solidFill>
            <a:latin typeface="Arial" panose="020B0604020202020204" pitchFamily="34" charset="0"/>
            <a:ea typeface="ＭＳ Ｐゴシック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00433</cdr:x>
      <cdr:y>0.03996</cdr:y>
    </cdr:from>
    <cdr:to>
      <cdr:x>0.04731</cdr:x>
      <cdr:y>0.83254</cdr:y>
    </cdr:to>
    <cdr:sp macro="" textlink="">
      <cdr:nvSpPr>
        <cdr:cNvPr id="2050" name="Text Box 2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6794" y="128093"/>
          <a:ext cx="265985" cy="254089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vertOverflow="clip" vert="vert270" wrap="square" lIns="27432" tIns="0" rIns="0" bIns="0" anchor="b" upright="1"/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en-US" altLang="ja-JP" sz="1150" b="0" i="0" u="none" strike="noStrike" baseline="0" dirty="0">
              <a:solidFill>
                <a:srgbClr val="000000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rPr>
            <a:t>Progression-Free  Survival Probability</a:t>
          </a:r>
          <a:endParaRPr lang="ja-JP" altLang="en-US" sz="1150" b="0" i="0" u="none" strike="noStrike" baseline="0" dirty="0">
            <a:solidFill>
              <a:srgbClr val="000000"/>
            </a:solidFill>
            <a:latin typeface="Arial" panose="020B0604020202020204" pitchFamily="34" charset="0"/>
            <a:ea typeface="ＭＳ Ｐゴシック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1607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1476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8145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369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4309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0460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773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868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5750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1313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4372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1C57B9-D5DB-479C-B17C-35254075462E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9858F6-6DAA-4982-BCE3-26A8E523F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743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8200" y="192341"/>
            <a:ext cx="10515600" cy="1325563"/>
          </a:xfrm>
        </p:spPr>
        <p:txBody>
          <a:bodyPr>
            <a:noAutofit/>
          </a:bodyPr>
          <a:lstStyle/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Overall survival based on investigator assessment (in the main cohort with measurable disease, n = 50)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コンテンツ プレースホルダー 5">
            <a:extLst>
              <a:ext uri="{FF2B5EF4-FFF2-40B4-BE49-F238E27FC236}">
                <a16:creationId xmlns:a16="http://schemas.microsoft.com/office/drawing/2014/main" id="{00000000-0008-0000-0000-00000204000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75632961"/>
              </p:ext>
            </p:extLst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04436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Progression-free survival based on investigator assessment (in the exploratory cohort without </a:t>
            </a:r>
            <a:r>
              <a:rPr lang="en-US" altLang="ja-JP" sz="2800" dirty="0"/>
              <a:t>measurable</a:t>
            </a:r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 disease, n = 7)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コンテンツ プレースホルダー 7">
            <a:extLst>
              <a:ext uri="{FF2B5EF4-FFF2-40B4-BE49-F238E27FC236}">
                <a16:creationId xmlns:a16="http://schemas.microsoft.com/office/drawing/2014/main" id="{00000000-0008-0000-0000-00000204000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079571529"/>
              </p:ext>
            </p:extLst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51108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Meiryo UI"/>
        <a:ea typeface="メイリオ"/>
        <a:cs typeface=""/>
      </a:majorFont>
      <a:minorFont>
        <a:latin typeface="Meiryo UI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4</Words>
  <Application>Microsoft Office PowerPoint</Application>
  <PresentationFormat>ワイド画面</PresentationFormat>
  <Paragraphs>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Meiryo UI</vt:lpstr>
      <vt:lpstr>ＭＳ Ｐゴシック</vt:lpstr>
      <vt:lpstr>メイリオ</vt:lpstr>
      <vt:lpstr>Arial</vt:lpstr>
      <vt:lpstr>Office テーマ</vt:lpstr>
      <vt:lpstr>Supplementary Figure 1: Overall survival based on investigator assessment (in the main cohort with measurable disease, n = 50)</vt:lpstr>
      <vt:lpstr>Supplementary Figure 2: Progression-free survival based on investigator assessment (in the exploratory cohort without measurable disease, n = 7)</vt:lpstr>
    </vt:vector>
  </TitlesOfParts>
  <Company>N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: Progression-free survival by investigator assessment (Main cohort with target lesion, n = 50)</dc:title>
  <dc:creator>ncc</dc:creator>
  <cp:lastModifiedBy>Shimoi</cp:lastModifiedBy>
  <cp:revision>18</cp:revision>
  <dcterms:created xsi:type="dcterms:W3CDTF">2023-05-18T09:24:39Z</dcterms:created>
  <dcterms:modified xsi:type="dcterms:W3CDTF">2024-01-27T02:10:22Z</dcterms:modified>
</cp:coreProperties>
</file>